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788" r:id="rId2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2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607747BE-B486-4ADA-9DD3-B99416C36E09}"/>
              </a:ext>
            </a:extLst>
          </p:cNvPr>
          <p:cNvSpPr txBox="1"/>
          <p:nvPr/>
        </p:nvSpPr>
        <p:spPr>
          <a:xfrm>
            <a:off x="418743" y="105059"/>
            <a:ext cx="1133172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9 Fluorescent-Activated Cell Sorting CD44</a:t>
            </a:r>
            <a:r>
              <a:rPr lang="en-US" sz="1100" b="1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kumimoji="0" lang="en-US" sz="1100" b="1" i="0" u="none" strike="noStrike" kern="1200" cap="none" spc="0" normalizeH="0" baseline="3000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gh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C-3M cell line stained with stemness markers (CD44) and sorted CD44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ells, followed by CONV-TOPO, METRO-TOPO, CONV-DTX, and combination (CONV-DTX+METRO-TOPO) therapy and cell cytotoxicity and caspase3/7 levels assessed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ytotoxicity profiling by MTT showed combination (CONV-DTX+METRO-TOPO) reduces cell survival compared with other treatments  CONV-TOPO&gt;CONV-DTX&gt;METRO-TOPO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R-mCRPC- PC-3M showed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ombination (CONV-DTX+METRO-TOPO) reduces levels the most of apoptosis compared to other treatments. (*</a:t>
            </a:r>
            <a:r>
              <a:rPr kumimoji="0" lang="it-IT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0" lang="it-IT" sz="11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&lt;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5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52BB0CEE-B684-05DA-3A62-B8DAEC7E4F4A}"/>
              </a:ext>
            </a:extLst>
          </p:cNvPr>
          <p:cNvGrpSpPr/>
          <p:nvPr/>
        </p:nvGrpSpPr>
        <p:grpSpPr>
          <a:xfrm>
            <a:off x="3107018" y="1629001"/>
            <a:ext cx="5368769" cy="2686404"/>
            <a:chOff x="3107018" y="1629001"/>
            <a:chExt cx="5368769" cy="268640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4DA61E0-54BE-424D-871A-B05DBC917D61}"/>
                </a:ext>
              </a:extLst>
            </p:cNvPr>
            <p:cNvGrpSpPr/>
            <p:nvPr/>
          </p:nvGrpSpPr>
          <p:grpSpPr>
            <a:xfrm>
              <a:off x="3107018" y="1781163"/>
              <a:ext cx="5368769" cy="2534242"/>
              <a:chOff x="3107018" y="1781163"/>
              <a:chExt cx="5368769" cy="2534242"/>
            </a:xfrm>
          </p:grpSpPr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2AB1F20A-2334-4DB7-81E1-E6D8B3BAE224}"/>
                  </a:ext>
                </a:extLst>
              </p:cNvPr>
              <p:cNvGrpSpPr/>
              <p:nvPr/>
            </p:nvGrpSpPr>
            <p:grpSpPr>
              <a:xfrm>
                <a:off x="5802186" y="1817794"/>
                <a:ext cx="2673601" cy="2461856"/>
                <a:chOff x="5686089" y="1782877"/>
                <a:chExt cx="2673601" cy="2461856"/>
              </a:xfrm>
            </p:grpSpPr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5799344D-763F-41B3-AF7E-2E3D6DD65912}"/>
                    </a:ext>
                  </a:extLst>
                </p:cNvPr>
                <p:cNvGrpSpPr/>
                <p:nvPr/>
              </p:nvGrpSpPr>
              <p:grpSpPr>
                <a:xfrm>
                  <a:off x="5686089" y="1782877"/>
                  <a:ext cx="2673601" cy="2461856"/>
                  <a:chOff x="272118" y="671923"/>
                  <a:chExt cx="2673601" cy="2461856"/>
                </a:xfrm>
              </p:grpSpPr>
              <p:pic>
                <p:nvPicPr>
                  <p:cNvPr id="2" name="Picture 1">
                    <a:extLst>
                      <a:ext uri="{FF2B5EF4-FFF2-40B4-BE49-F238E27FC236}">
                        <a16:creationId xmlns:a16="http://schemas.microsoft.com/office/drawing/2014/main" id="{C29DE222-66B0-48CD-B47D-367D4E152AC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0680" t="9699" r="2688" b="43026"/>
                  <a:stretch/>
                </p:blipFill>
                <p:spPr>
                  <a:xfrm>
                    <a:off x="489528" y="757382"/>
                    <a:ext cx="2124364" cy="2050473"/>
                  </a:xfrm>
                  <a:prstGeom prst="rect">
                    <a:avLst/>
                  </a:prstGeom>
                </p:spPr>
              </p:pic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4D4CD43E-B747-4531-A525-272A344309E9}"/>
                      </a:ext>
                    </a:extLst>
                  </p:cNvPr>
                  <p:cNvSpPr txBox="1"/>
                  <p:nvPr/>
                </p:nvSpPr>
                <p:spPr>
                  <a:xfrm>
                    <a:off x="719833" y="2717063"/>
                    <a:ext cx="55019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</a:t>
                    </a: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F8C8A930-F248-4FD4-9526-B816FC67C3A6}"/>
                      </a:ext>
                    </a:extLst>
                  </p:cNvPr>
                  <p:cNvSpPr txBox="1"/>
                  <p:nvPr/>
                </p:nvSpPr>
                <p:spPr>
                  <a:xfrm>
                    <a:off x="1067931" y="2717679"/>
                    <a:ext cx="52009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V</a:t>
                    </a:r>
                  </a:p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OPO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B8406784-CA03-4256-8434-CA549A55D657}"/>
                      </a:ext>
                    </a:extLst>
                  </p:cNvPr>
                  <p:cNvSpPr txBox="1"/>
                  <p:nvPr/>
                </p:nvSpPr>
                <p:spPr>
                  <a:xfrm>
                    <a:off x="1336818" y="2711953"/>
                    <a:ext cx="65570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V</a:t>
                    </a:r>
                  </a:p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TX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FF418A24-404E-4E41-8F7D-88FAECB040DC}"/>
                      </a:ext>
                    </a:extLst>
                  </p:cNvPr>
                  <p:cNvSpPr txBox="1"/>
                  <p:nvPr/>
                </p:nvSpPr>
                <p:spPr>
                  <a:xfrm>
                    <a:off x="1702917" y="2711953"/>
                    <a:ext cx="65570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RO</a:t>
                    </a:r>
                  </a:p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7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OPO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88C1C512-E778-4CA7-82E2-AE3027584850}"/>
                      </a:ext>
                    </a:extLst>
                  </p:cNvPr>
                  <p:cNvSpPr txBox="1"/>
                  <p:nvPr/>
                </p:nvSpPr>
                <p:spPr>
                  <a:xfrm>
                    <a:off x="783376" y="671923"/>
                    <a:ext cx="1164101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sz="1200" b="1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C-3M</a:t>
                    </a:r>
                    <a:r>
                      <a:rPr kumimoji="0" lang="en-US" sz="12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CD44</a:t>
                    </a:r>
                    <a:r>
                      <a:rPr kumimoji="0" lang="en-US" sz="1200" b="1" i="0" u="none" strike="noStrike" kern="0" cap="none" spc="0" normalizeH="0" baseline="3000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DEE933F5-9820-4376-A1C4-B15769225F42}"/>
                      </a:ext>
                    </a:extLst>
                  </p:cNvPr>
                  <p:cNvSpPr txBox="1"/>
                  <p:nvPr/>
                </p:nvSpPr>
                <p:spPr>
                  <a:xfrm>
                    <a:off x="1991069" y="2715280"/>
                    <a:ext cx="954650" cy="4154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BI</a:t>
                    </a:r>
                  </a:p>
                  <a:p>
                    <a:pPr algn="ctr"/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V-DTX+</a:t>
                    </a:r>
                  </a:p>
                  <a:p>
                    <a:pPr algn="ctr"/>
                    <a:r>
                      <a:rPr lang="en-US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TRO-TOPO</a:t>
                    </a:r>
                  </a:p>
                </p:txBody>
              </p:sp>
              <p:sp>
                <p:nvSpPr>
                  <p:cNvPr id="19" name="Rectangle 18">
                    <a:extLst>
                      <a:ext uri="{FF2B5EF4-FFF2-40B4-BE49-F238E27FC236}">
                        <a16:creationId xmlns:a16="http://schemas.microsoft.com/office/drawing/2014/main" id="{E52992A3-4A35-4131-A49B-A3CB39DDB283}"/>
                      </a:ext>
                    </a:extLst>
                  </p:cNvPr>
                  <p:cNvSpPr/>
                  <p:nvPr/>
                </p:nvSpPr>
                <p:spPr>
                  <a:xfrm>
                    <a:off x="272118" y="706498"/>
                    <a:ext cx="2530903" cy="2427281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F308EEDE-5852-4595-A3C0-BD9274F23E33}"/>
                    </a:ext>
                  </a:extLst>
                </p:cNvPr>
                <p:cNvSpPr txBox="1"/>
                <p:nvPr/>
              </p:nvSpPr>
              <p:spPr>
                <a:xfrm rot="16200000">
                  <a:off x="4762002" y="2790714"/>
                  <a:ext cx="222849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old Change Caspase 3/7 Activity</a:t>
                  </a:r>
                </a:p>
              </p:txBody>
            </p:sp>
          </p:grp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E08208B4-E8F1-4012-ABA8-A72FEA568DBD}"/>
                  </a:ext>
                </a:extLst>
              </p:cNvPr>
              <p:cNvGrpSpPr/>
              <p:nvPr/>
            </p:nvGrpSpPr>
            <p:grpSpPr>
              <a:xfrm>
                <a:off x="3149749" y="1781163"/>
                <a:ext cx="2736547" cy="2534242"/>
                <a:chOff x="3152038" y="1659074"/>
                <a:chExt cx="2736547" cy="2534242"/>
              </a:xfrm>
            </p:grpSpPr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D38615D8-57AE-4C3F-88F2-487210E7826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22435" t="10471" r="4514" b="43409"/>
                <a:stretch/>
              </p:blipFill>
              <p:spPr>
                <a:xfrm>
                  <a:off x="3392680" y="1851244"/>
                  <a:ext cx="2136449" cy="2000355"/>
                </a:xfrm>
                <a:prstGeom prst="rect">
                  <a:avLst/>
                </a:prstGeom>
              </p:spPr>
            </p:pic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C038DE37-015F-4994-8748-C22B5EB81B34}"/>
                    </a:ext>
                  </a:extLst>
                </p:cNvPr>
                <p:cNvSpPr txBox="1"/>
                <p:nvPr/>
              </p:nvSpPr>
              <p:spPr>
                <a:xfrm>
                  <a:off x="3688282" y="3766271"/>
                  <a:ext cx="55019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CONT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671291A2-57AC-440E-BB2B-E074D18FF2EB}"/>
                    </a:ext>
                  </a:extLst>
                </p:cNvPr>
                <p:cNvSpPr txBox="1"/>
                <p:nvPr/>
              </p:nvSpPr>
              <p:spPr>
                <a:xfrm>
                  <a:off x="4045219" y="3774817"/>
                  <a:ext cx="52009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CONV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TOPO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5072F784-15FE-4852-BAAB-14AF8B0CF926}"/>
                    </a:ext>
                  </a:extLst>
                </p:cNvPr>
                <p:cNvSpPr txBox="1"/>
                <p:nvPr/>
              </p:nvSpPr>
              <p:spPr>
                <a:xfrm>
                  <a:off x="4313666" y="3777517"/>
                  <a:ext cx="65570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CONV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DTX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59317019-0A21-4A0D-BCD2-D59A64C9532A}"/>
                    </a:ext>
                  </a:extLst>
                </p:cNvPr>
                <p:cNvSpPr txBox="1"/>
                <p:nvPr/>
              </p:nvSpPr>
              <p:spPr>
                <a:xfrm>
                  <a:off x="4672508" y="3774817"/>
                  <a:ext cx="65570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METRO</a:t>
                  </a: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7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TOPO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43CE60B4-33CC-42E1-888A-E17516F26A99}"/>
                    </a:ext>
                  </a:extLst>
                </p:cNvPr>
                <p:cNvSpPr txBox="1"/>
                <p:nvPr/>
              </p:nvSpPr>
              <p:spPr>
                <a:xfrm>
                  <a:off x="4933935" y="3777818"/>
                  <a:ext cx="954650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MBI</a:t>
                  </a:r>
                </a:p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V-DTX+</a:t>
                  </a:r>
                </a:p>
                <a:p>
                  <a:pPr algn="ctr"/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TRO-TOPO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1BBA5BD9-D686-46B3-B403-92D7D6165DE5}"/>
                    </a:ext>
                  </a:extLst>
                </p:cNvPr>
                <p:cNvSpPr txBox="1"/>
                <p:nvPr/>
              </p:nvSpPr>
              <p:spPr>
                <a:xfrm rot="16200000">
                  <a:off x="2131438" y="2763222"/>
                  <a:ext cx="24545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Fold Change Cytotoxicity-MTT-IC</a:t>
                  </a:r>
                  <a:r>
                    <a:rPr kumimoji="0" lang="en-US" sz="1000" b="1" i="0" u="none" strike="noStrike" kern="0" cap="none" spc="0" normalizeH="0" baseline="-25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50/2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53CD6315-E9F0-4898-A343-907848806532}"/>
                    </a:ext>
                  </a:extLst>
                </p:cNvPr>
                <p:cNvSpPr txBox="1"/>
                <p:nvPr/>
              </p:nvSpPr>
              <p:spPr>
                <a:xfrm>
                  <a:off x="3986931" y="1713745"/>
                  <a:ext cx="11641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1200" b="1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C-3M</a:t>
                  </a:r>
                  <a:r>
                    <a:rPr kumimoji="0" lang="en-US" sz="12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-CD44</a:t>
                  </a:r>
                  <a:r>
                    <a:rPr kumimoji="0" lang="en-US" sz="1200" b="1" i="0" u="none" strike="noStrike" kern="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0557328A-72B5-44F2-8EC8-86ACA3DDC2F4}"/>
                    </a:ext>
                  </a:extLst>
                </p:cNvPr>
                <p:cNvSpPr/>
                <p:nvPr/>
              </p:nvSpPr>
              <p:spPr>
                <a:xfrm>
                  <a:off x="3152038" y="1730281"/>
                  <a:ext cx="2616372" cy="242428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1720F66-BC3C-4E09-8EAE-7D09EB03C2BC}"/>
                  </a:ext>
                </a:extLst>
              </p:cNvPr>
              <p:cNvSpPr txBox="1"/>
              <p:nvPr/>
            </p:nvSpPr>
            <p:spPr>
              <a:xfrm>
                <a:off x="3107018" y="1826732"/>
                <a:ext cx="3581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/>
                  </a:rPr>
                  <a:t>I.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1130037-B80C-454E-B324-BF9B493912AB}"/>
                  </a:ext>
                </a:extLst>
              </p:cNvPr>
              <p:cNvSpPr txBox="1"/>
              <p:nvPr/>
            </p:nvSpPr>
            <p:spPr>
              <a:xfrm>
                <a:off x="5739691" y="1793990"/>
                <a:ext cx="3581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dirty="0">
                    <a:solidFill>
                      <a:prstClr val="black"/>
                    </a:solidFill>
                    <a:latin typeface="Calibri" panose="020F0502020204030204"/>
                  </a:rPr>
                  <a:t>II.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30378B7-B48C-8382-09DB-5E73C9CB66CC}"/>
                </a:ext>
              </a:extLst>
            </p:cNvPr>
            <p:cNvSpPr txBox="1"/>
            <p:nvPr/>
          </p:nvSpPr>
          <p:spPr>
            <a:xfrm>
              <a:off x="3647493" y="1629001"/>
              <a:ext cx="1949871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upplementary Fig. 9A</a:t>
              </a:r>
              <a:endParaRPr lang="en-US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E0E2B63-63EB-1FD0-A683-59F71576ADB9}"/>
                </a:ext>
              </a:extLst>
            </p:cNvPr>
            <p:cNvSpPr txBox="1"/>
            <p:nvPr/>
          </p:nvSpPr>
          <p:spPr>
            <a:xfrm>
              <a:off x="6205453" y="1639439"/>
              <a:ext cx="1949871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upplementary Fig. 9B</a:t>
              </a:r>
              <a:endParaRPr lang="en-US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D6CEDD9-24E1-DA7E-93B6-0EC06B4E6751}"/>
                </a:ext>
              </a:extLst>
            </p:cNvPr>
            <p:cNvSpPr txBox="1"/>
            <p:nvPr/>
          </p:nvSpPr>
          <p:spPr>
            <a:xfrm>
              <a:off x="4097914" y="2011574"/>
              <a:ext cx="181053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138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2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4.5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20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4.5nM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59A7F07-967F-BA95-795A-3D8C6D2527E2}"/>
                </a:ext>
              </a:extLst>
            </p:cNvPr>
            <p:cNvSpPr txBox="1"/>
            <p:nvPr/>
          </p:nvSpPr>
          <p:spPr>
            <a:xfrm>
              <a:off x="5179378" y="326558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486A1740-76FC-C4FE-BB19-40D6857DFC43}"/>
                </a:ext>
              </a:extLst>
            </p:cNvPr>
            <p:cNvSpPr txBox="1"/>
            <p:nvPr/>
          </p:nvSpPr>
          <p:spPr>
            <a:xfrm>
              <a:off x="4839485" y="288557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A08F83-3A41-A51D-F766-76D4ED9838B6}"/>
                </a:ext>
              </a:extLst>
            </p:cNvPr>
            <p:cNvSpPr txBox="1"/>
            <p:nvPr/>
          </p:nvSpPr>
          <p:spPr>
            <a:xfrm>
              <a:off x="6373958" y="335234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43F2564-FCDF-528A-41D5-AAE0D918C58B}"/>
                </a:ext>
              </a:extLst>
            </p:cNvPr>
            <p:cNvSpPr txBox="1"/>
            <p:nvPr/>
          </p:nvSpPr>
          <p:spPr>
            <a:xfrm>
              <a:off x="6716845" y="3278518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D3ADA04-B6EE-BCE0-37FE-DC690939A8A6}"/>
                </a:ext>
              </a:extLst>
            </p:cNvPr>
            <p:cNvSpPr txBox="1"/>
            <p:nvPr/>
          </p:nvSpPr>
          <p:spPr>
            <a:xfrm>
              <a:off x="6232740" y="1964787"/>
              <a:ext cx="181053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138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2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4.5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20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+METRO-TOPO (14.5nM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98309071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7</TotalTime>
  <Words>194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2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1:54Z</dcterms:modified>
</cp:coreProperties>
</file>